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528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257404294"/>
              </p:ext>
            </p:extLst>
          </p:nvPr>
        </p:nvGraphicFramePr>
        <p:xfrm>
          <a:off x="710726" y="2435115"/>
          <a:ext cx="11443905" cy="14061667"/>
        </p:xfrm>
        <a:graphic>
          <a:graphicData uri="http://schemas.openxmlformats.org/drawingml/2006/table">
            <a:tbl>
              <a:tblPr firstRow="1" firstCol="1" bandRow="1"/>
              <a:tblGrid>
                <a:gridCol w="638931">
                  <a:extLst>
                    <a:ext uri="{9D8B030D-6E8A-4147-A177-3AD203B41FA5}">
                      <a16:colId xmlns:a16="http://schemas.microsoft.com/office/drawing/2014/main" xmlns="" val="1610623545"/>
                    </a:ext>
                  </a:extLst>
                </a:gridCol>
                <a:gridCol w="2488502">
                  <a:extLst>
                    <a:ext uri="{9D8B030D-6E8A-4147-A177-3AD203B41FA5}">
                      <a16:colId xmlns:a16="http://schemas.microsoft.com/office/drawing/2014/main" xmlns="" val="3123950308"/>
                    </a:ext>
                  </a:extLst>
                </a:gridCol>
                <a:gridCol w="1124262">
                  <a:extLst>
                    <a:ext uri="{9D8B030D-6E8A-4147-A177-3AD203B41FA5}">
                      <a16:colId xmlns:a16="http://schemas.microsoft.com/office/drawing/2014/main" xmlns="" val="880481821"/>
                    </a:ext>
                  </a:extLst>
                </a:gridCol>
                <a:gridCol w="1334124">
                  <a:extLst>
                    <a:ext uri="{9D8B030D-6E8A-4147-A177-3AD203B41FA5}">
                      <a16:colId xmlns:a16="http://schemas.microsoft.com/office/drawing/2014/main" xmlns="" val="2282471623"/>
                    </a:ext>
                  </a:extLst>
                </a:gridCol>
                <a:gridCol w="1022906">
                  <a:extLst>
                    <a:ext uri="{9D8B030D-6E8A-4147-A177-3AD203B41FA5}">
                      <a16:colId xmlns:a16="http://schemas.microsoft.com/office/drawing/2014/main" xmlns="" val="3806258590"/>
                    </a:ext>
                  </a:extLst>
                </a:gridCol>
                <a:gridCol w="994701">
                  <a:extLst>
                    <a:ext uri="{9D8B030D-6E8A-4147-A177-3AD203B41FA5}">
                      <a16:colId xmlns:a16="http://schemas.microsoft.com/office/drawing/2014/main" xmlns="" val="2621145451"/>
                    </a:ext>
                  </a:extLst>
                </a:gridCol>
                <a:gridCol w="1905498">
                  <a:extLst>
                    <a:ext uri="{9D8B030D-6E8A-4147-A177-3AD203B41FA5}">
                      <a16:colId xmlns:a16="http://schemas.microsoft.com/office/drawing/2014/main" xmlns="" val="2842071487"/>
                    </a:ext>
                  </a:extLst>
                </a:gridCol>
                <a:gridCol w="1296050">
                  <a:extLst>
                    <a:ext uri="{9D8B030D-6E8A-4147-A177-3AD203B41FA5}">
                      <a16:colId xmlns:a16="http://schemas.microsoft.com/office/drawing/2014/main" xmlns="" val="1990700189"/>
                    </a:ext>
                  </a:extLst>
                </a:gridCol>
                <a:gridCol w="638931">
                  <a:extLst>
                    <a:ext uri="{9D8B030D-6E8A-4147-A177-3AD203B41FA5}">
                      <a16:colId xmlns:a16="http://schemas.microsoft.com/office/drawing/2014/main" xmlns="" val="2391213309"/>
                    </a:ext>
                  </a:extLst>
                </a:gridCol>
              </a:tblGrid>
              <a:tr h="42672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ata N.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thor (year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se definition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untry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opulation group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iagnostic metho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otal participant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male/female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FS cases (male/female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b="1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 (%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18192061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hi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8 [32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hin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,139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63 (87/76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9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6243295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li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6 [38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-200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 (R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,396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1449526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usu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5 [6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/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nada (R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9,101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06 (313/69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7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37918773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incent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2 [64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 (R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3,841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6 (12/6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3792174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-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acul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1 [37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hysic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3,15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16437014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-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CC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6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04055668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-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C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2539173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Bhui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1 [65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 (R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,281 (1,944/2,33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8 (50/58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5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8845003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amaguchi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1 [66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p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430 (867/56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 (8/6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9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57439271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ijhof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1 [67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etherlands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hysic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3,636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1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0649171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an't Leve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0 [68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etherlands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,062 (4,169/4,89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9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9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5292974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ho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9 [69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,459 (700/1,75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1 (14/37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0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3150972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indent="152400"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     Brazil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,914 (794/3,120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3 (13/50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6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9068721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S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8 [70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644 (815/82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 (1/0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05901972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SH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8 [71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71 (637/33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 (0/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9328349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eve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7 [72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,62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0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5487824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joku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7 [50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igeri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087 (455/59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 (0/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6256708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aralikar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7 [7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/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di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87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.0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8890214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ime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7 [74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42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7886877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CH.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5 [55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648 (591/1,057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 (2/8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0055519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</a:t>
                      </a:r>
                      <a:endParaRPr lang="ko-KR" sz="13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urberg et al., </a:t>
                      </a:r>
                      <a:r>
                        <a:rPr lang="en-US" sz="13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5 [75]</a:t>
                      </a:r>
                      <a:endParaRPr lang="ko-KR" sz="13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,591 (1,607/2,98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6 (45/81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7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76427442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vengard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5 [76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weden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405 (15387/16017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32 (140/59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3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3477003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Yiu and Qiu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5 [77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hina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013 (341/67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5 (13/4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.4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7043524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uiber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4 [78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etherlands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,499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 (144/55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.6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895982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one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4 [79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,586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89980081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armer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4 [80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46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 (9/26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3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9096553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halder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3 [81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&amp;A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,24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2986125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ye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3 [54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,162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 (7/36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7454179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cCauley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2 [82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99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2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452626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-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índal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2 [34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celan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,520 (1,056/1,415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 (12/4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1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11314167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-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60401645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-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xfor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4 (20/7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.7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77998240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-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stral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2 (28/16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.6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41585122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CH.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0 [8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8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2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889475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i JD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00 [84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526 (906/620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 (13/18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0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23422792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i JD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9 [85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ore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30 (327/20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 (5/5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8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6429263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so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9 [5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673 (16057/1232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9 (67/5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6068091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so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8 [86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0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7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4214498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eele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8 [87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,627 (7,198/7,40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3 (8/25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12333727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ukuda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7 [88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689 (748/941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.4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61483305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-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Wessely </a:t>
                      </a: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7 [16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985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2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6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52550728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-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xfor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2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55368025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-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stral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4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78356708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6-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2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5970321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7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erslui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7 [89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etherlands (R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3,00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05647284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inowa and Jiamo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6 [90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DC-1994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pan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5,50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93 (129/244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877849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9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awrie and Pelosi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5 [60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xfor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95 (322/373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 (2/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58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63632561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Buchwald and Umali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5 [91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,066 (1,226/1,83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 (1/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0025427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so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5 [92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13 (367/501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 (0/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35707147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son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3 [9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 (P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,47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 (2/9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7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0645038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-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Bates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3 [39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xford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&amp;M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95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11253862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-2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0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82785098"/>
                  </a:ext>
                </a:extLst>
              </a:tr>
              <a:tr h="26011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-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stral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 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3913698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ce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2 [33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lmes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S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terview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538 (5556/7982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 (0/1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62075538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5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-Yen and Mc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1 [36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VES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K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P) 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hysic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8,99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3 (102/187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3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81364906"/>
                  </a:ext>
                </a:extLst>
              </a:tr>
              <a:tr h="2299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loyd et al., </a:t>
                      </a:r>
                      <a:r>
                        <a:rPr lang="en-US" sz="13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0 [25]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stral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ustralia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ral (C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hysician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8,993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2 (-/-)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79832949"/>
                  </a:ext>
                </a:extLst>
              </a:tr>
              <a:tr h="426720">
                <a:tc gridSpan="9">
                  <a:txBody>
                    <a:bodyPr/>
                    <a:lstStyle/>
                    <a:p>
                      <a:pPr algn="just" latinLnBrk="0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1130300" algn="l"/>
                        </a:tabLst>
                      </a:pPr>
                      <a:r>
                        <a:rPr lang="en-US" sz="13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&amp;A, Children and adolescents. Sp, specific population. I&amp;M, interview and medical test. MR, medical record. PVES, </a:t>
                      </a:r>
                      <a:r>
                        <a:rPr lang="en-US" sz="13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stviral exhaustion syndrome. (R), retrospective studies, otherwise, prospective studies. (C), community. (P), primary care. </a:t>
                      </a:r>
                      <a:endParaRPr lang="ko-KR" sz="13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267631634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677677" y="2042299"/>
            <a:ext cx="6485444" cy="6460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52400"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11303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indent="76199" defTabSz="914380">
              <a:tabLst>
                <a:tab pos="1130275" algn="l"/>
              </a:tabLst>
            </a:pPr>
            <a:r>
              <a:rPr lang="en-US" altLang="ko-KR" sz="1799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dditional file 1 </a:t>
            </a:r>
            <a:r>
              <a:rPr lang="en-US" altLang="ko-KR" sz="1799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xtracted raw data from the included </a:t>
            </a:r>
            <a:r>
              <a:rPr lang="en-US" altLang="ko-KR" sz="1799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udies</a:t>
            </a:r>
            <a:endParaRPr lang="en-US" altLang="ko-KR" sz="1799" dirty="0"/>
          </a:p>
          <a:p>
            <a:pPr indent="76199" defTabSz="914380">
              <a:tabLst>
                <a:tab pos="1130275" algn="l"/>
              </a:tabLst>
            </a:pPr>
            <a:endParaRPr lang="en-US" altLang="ko-KR" sz="1799" dirty="0"/>
          </a:p>
        </p:txBody>
      </p:sp>
    </p:spTree>
    <p:extLst>
      <p:ext uri="{BB962C8B-B14F-4D97-AF65-F5344CB8AC3E}">
        <p14:creationId xmlns:p14="http://schemas.microsoft.com/office/powerpoint/2010/main" xmlns="" val="34265405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1213</Words>
  <Application>Microsoft Office PowerPoint</Application>
  <PresentationFormat>Custom</PresentationFormat>
  <Paragraphs>4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4:46Z</dcterms:modified>
</cp:coreProperties>
</file>